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116638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192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8964" autoAdjust="0"/>
  </p:normalViewPr>
  <p:slideViewPr>
    <p:cSldViewPr snapToGrid="0" snapToObjects="1">
      <p:cViewPr varScale="1">
        <p:scale>
          <a:sx n="128" d="100"/>
          <a:sy n="128" d="100"/>
        </p:scale>
        <p:origin x="2928" y="176"/>
      </p:cViewPr>
      <p:guideLst>
        <p:guide orient="horz" pos="2160"/>
        <p:guide pos="192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748" y="2130426"/>
            <a:ext cx="5199142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7496" y="3886200"/>
            <a:ext cx="4281647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1E0FB-72FF-EA48-B45F-D2108724EA02}" type="datetimeFigureOut">
              <a:rPr lang="en-US" smtClean="0"/>
              <a:t>10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6C5E0-D5FF-B245-92EA-BB0F24375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3669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1E0FB-72FF-EA48-B45F-D2108724EA02}" type="datetimeFigureOut">
              <a:rPr lang="en-US" smtClean="0"/>
              <a:t>10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6C5E0-D5FF-B245-92EA-BB0F24375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73143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34562" y="274639"/>
            <a:ext cx="1376244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05832" y="274639"/>
            <a:ext cx="4026787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1E0FB-72FF-EA48-B45F-D2108724EA02}" type="datetimeFigureOut">
              <a:rPr lang="en-US" smtClean="0"/>
              <a:t>10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6C5E0-D5FF-B245-92EA-BB0F24375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83859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1E0FB-72FF-EA48-B45F-D2108724EA02}" type="datetimeFigureOut">
              <a:rPr lang="en-US" smtClean="0"/>
              <a:t>10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6C5E0-D5FF-B245-92EA-BB0F24375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11438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3172" y="4406901"/>
            <a:ext cx="5199142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3172" y="2906713"/>
            <a:ext cx="5199142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1E0FB-72FF-EA48-B45F-D2108724EA02}" type="datetimeFigureOut">
              <a:rPr lang="en-US" smtClean="0"/>
              <a:t>10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6C5E0-D5FF-B245-92EA-BB0F24375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72959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05832" y="1600201"/>
            <a:ext cx="270151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09291" y="1600201"/>
            <a:ext cx="270151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1E0FB-72FF-EA48-B45F-D2108724EA02}" type="datetimeFigureOut">
              <a:rPr lang="en-US" smtClean="0"/>
              <a:t>10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6C5E0-D5FF-B245-92EA-BB0F24375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89208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5832" y="1535113"/>
            <a:ext cx="270257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5832" y="2174875"/>
            <a:ext cx="270257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07167" y="1535113"/>
            <a:ext cx="2703639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07167" y="2174875"/>
            <a:ext cx="2703639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1E0FB-72FF-EA48-B45F-D2108724EA02}" type="datetimeFigureOut">
              <a:rPr lang="en-US" smtClean="0"/>
              <a:t>10/1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6C5E0-D5FF-B245-92EA-BB0F24375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0589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1E0FB-72FF-EA48-B45F-D2108724EA02}" type="datetimeFigureOut">
              <a:rPr lang="en-US" smtClean="0"/>
              <a:t>10/1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6C5E0-D5FF-B245-92EA-BB0F24375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27926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1E0FB-72FF-EA48-B45F-D2108724EA02}" type="datetimeFigureOut">
              <a:rPr lang="en-US" smtClean="0"/>
              <a:t>10/1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6C5E0-D5FF-B245-92EA-BB0F24375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86977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5832" y="273050"/>
            <a:ext cx="2012332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391435" y="273051"/>
            <a:ext cx="341937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05832" y="1435101"/>
            <a:ext cx="2012332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1E0FB-72FF-EA48-B45F-D2108724EA02}" type="datetimeFigureOut">
              <a:rPr lang="en-US" smtClean="0"/>
              <a:t>10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6C5E0-D5FF-B245-92EA-BB0F24375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5245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98904" y="4800600"/>
            <a:ext cx="3669983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198904" y="612775"/>
            <a:ext cx="3669983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98904" y="5367338"/>
            <a:ext cx="3669983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1E0FB-72FF-EA48-B45F-D2108724EA02}" type="datetimeFigureOut">
              <a:rPr lang="en-US" smtClean="0"/>
              <a:t>10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6C5E0-D5FF-B245-92EA-BB0F24375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41024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05832" y="274638"/>
            <a:ext cx="5504974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5832" y="1600201"/>
            <a:ext cx="5504974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05832" y="6356351"/>
            <a:ext cx="142721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21E0FB-72FF-EA48-B45F-D2108724EA02}" type="datetimeFigureOut">
              <a:rPr lang="en-US" smtClean="0"/>
              <a:t>10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89852" y="6356351"/>
            <a:ext cx="193693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83590" y="6356351"/>
            <a:ext cx="142721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86C5E0-D5FF-B245-92EA-BB0F24375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33481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extBox 37"/>
          <p:cNvSpPr txBox="1"/>
          <p:nvPr/>
        </p:nvSpPr>
        <p:spPr>
          <a:xfrm rot="16200000">
            <a:off x="836478" y="1833353"/>
            <a:ext cx="75533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/>
                <a:cs typeface="Arial"/>
              </a:rPr>
              <a:t>Cold</a:t>
            </a:r>
          </a:p>
        </p:txBody>
      </p:sp>
      <p:sp>
        <p:nvSpPr>
          <p:cNvPr id="39" name="TextBox 38"/>
          <p:cNvSpPr txBox="1"/>
          <p:nvPr/>
        </p:nvSpPr>
        <p:spPr>
          <a:xfrm rot="16200000">
            <a:off x="663083" y="1085109"/>
            <a:ext cx="226376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/>
                <a:cs typeface="Arial"/>
              </a:rPr>
              <a:t>Pre-symptomatic</a:t>
            </a:r>
          </a:p>
        </p:txBody>
      </p:sp>
      <p:sp>
        <p:nvSpPr>
          <p:cNvPr id="40" name="TextBox 39"/>
          <p:cNvSpPr txBox="1"/>
          <p:nvPr/>
        </p:nvSpPr>
        <p:spPr>
          <a:xfrm rot="16200000">
            <a:off x="1478603" y="1339394"/>
            <a:ext cx="179408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/>
                <a:cs typeface="Arial"/>
              </a:rPr>
              <a:t>Symptomatic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947993" y="5452304"/>
            <a:ext cx="17018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/>
                <a:cs typeface="Arial"/>
              </a:rPr>
              <a:t>Subcellular</a:t>
            </a:r>
          </a:p>
          <a:p>
            <a:pPr algn="ctr"/>
            <a:r>
              <a:rPr lang="en-US" dirty="0">
                <a:latin typeface="Arial"/>
                <a:cs typeface="Arial"/>
              </a:rPr>
              <a:t>localization</a:t>
            </a:r>
          </a:p>
        </p:txBody>
      </p:sp>
      <p:pic>
        <p:nvPicPr>
          <p:cNvPr id="42" name="Picture 4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7994" y="2411924"/>
            <a:ext cx="540000" cy="3060000"/>
          </a:xfrm>
          <a:prstGeom prst="rect">
            <a:avLst/>
          </a:prstGeom>
        </p:spPr>
      </p:pic>
      <p:pic>
        <p:nvPicPr>
          <p:cNvPr id="43" name="Picture 4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30839" y="2415305"/>
            <a:ext cx="540000" cy="3060000"/>
          </a:xfrm>
          <a:prstGeom prst="rect">
            <a:avLst/>
          </a:prstGeom>
        </p:spPr>
      </p:pic>
      <p:pic>
        <p:nvPicPr>
          <p:cNvPr id="44" name="Picture 4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09794" y="2411924"/>
            <a:ext cx="540000" cy="3060000"/>
          </a:xfrm>
          <a:prstGeom prst="rect">
            <a:avLst/>
          </a:prstGeom>
        </p:spPr>
      </p:pic>
      <p:grpSp>
        <p:nvGrpSpPr>
          <p:cNvPr id="45" name="Group 44"/>
          <p:cNvGrpSpPr/>
          <p:nvPr/>
        </p:nvGrpSpPr>
        <p:grpSpPr>
          <a:xfrm>
            <a:off x="2894761" y="2204339"/>
            <a:ext cx="2309102" cy="3451145"/>
            <a:chOff x="1012007" y="336692"/>
            <a:chExt cx="2309102" cy="3451145"/>
          </a:xfrm>
        </p:grpSpPr>
        <p:sp>
          <p:nvSpPr>
            <p:cNvPr id="46" name="TextBox 45"/>
            <p:cNvSpPr txBox="1"/>
            <p:nvPr/>
          </p:nvSpPr>
          <p:spPr>
            <a:xfrm>
              <a:off x="1323046" y="336692"/>
              <a:ext cx="93707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/>
                  <a:cs typeface="Arial"/>
                </a:rPr>
                <a:t>Cytosol</a:t>
              </a:r>
            </a:p>
          </p:txBody>
        </p:sp>
        <p:sp>
          <p:nvSpPr>
            <p:cNvPr id="47" name="Rectangle 46"/>
            <p:cNvSpPr/>
            <p:nvPr/>
          </p:nvSpPr>
          <p:spPr>
            <a:xfrm>
              <a:off x="1012007" y="427383"/>
              <a:ext cx="287999" cy="179999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1323046" y="614068"/>
              <a:ext cx="132600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/>
                  <a:cs typeface="Arial"/>
                </a:rPr>
                <a:t>Chloroplast</a:t>
              </a:r>
            </a:p>
          </p:txBody>
        </p:sp>
        <p:sp>
          <p:nvSpPr>
            <p:cNvPr id="49" name="Rectangle 48"/>
            <p:cNvSpPr/>
            <p:nvPr/>
          </p:nvSpPr>
          <p:spPr>
            <a:xfrm>
              <a:off x="1012007" y="704759"/>
              <a:ext cx="287999" cy="179999"/>
            </a:xfrm>
            <a:prstGeom prst="rect">
              <a:avLst/>
            </a:prstGeom>
            <a:solidFill>
              <a:srgbClr val="FF00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1323046" y="875087"/>
              <a:ext cx="123363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/>
                  <a:cs typeface="Arial"/>
                </a:rPr>
                <a:t>Cytoplasm</a:t>
              </a:r>
            </a:p>
          </p:txBody>
        </p:sp>
        <p:sp>
          <p:nvSpPr>
            <p:cNvPr id="51" name="Rectangle 50"/>
            <p:cNvSpPr/>
            <p:nvPr/>
          </p:nvSpPr>
          <p:spPr>
            <a:xfrm>
              <a:off x="1012007" y="965778"/>
              <a:ext cx="287999" cy="179999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1323046" y="1127131"/>
              <a:ext cx="160923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/>
                  <a:cs typeface="Arial"/>
                </a:rPr>
                <a:t>Mitochondrion</a:t>
              </a:r>
            </a:p>
          </p:txBody>
        </p:sp>
        <p:sp>
          <p:nvSpPr>
            <p:cNvPr id="53" name="Rectangle 52"/>
            <p:cNvSpPr/>
            <p:nvPr/>
          </p:nvSpPr>
          <p:spPr>
            <a:xfrm>
              <a:off x="1012007" y="1217822"/>
              <a:ext cx="287999" cy="179999"/>
            </a:xfrm>
            <a:prstGeom prst="rect">
              <a:avLst/>
            </a:prstGeom>
            <a:solidFill>
              <a:srgbClr val="008000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1323046" y="1388150"/>
              <a:ext cx="85742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/>
                  <a:cs typeface="Arial"/>
                </a:rPr>
                <a:t>Plastid</a:t>
              </a:r>
            </a:p>
          </p:txBody>
        </p:sp>
        <p:sp>
          <p:nvSpPr>
            <p:cNvPr id="55" name="Rectangle 54"/>
            <p:cNvSpPr/>
            <p:nvPr/>
          </p:nvSpPr>
          <p:spPr>
            <a:xfrm>
              <a:off x="1012007" y="1478841"/>
              <a:ext cx="287999" cy="179999"/>
            </a:xfrm>
            <a:prstGeom prst="rect">
              <a:avLst/>
            </a:prstGeom>
            <a:solidFill>
              <a:srgbClr val="660066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1323046" y="1645807"/>
              <a:ext cx="9828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/>
                  <a:cs typeface="Arial"/>
                </a:rPr>
                <a:t>Nucleus</a:t>
              </a:r>
            </a:p>
          </p:txBody>
        </p:sp>
        <p:sp>
          <p:nvSpPr>
            <p:cNvPr id="57" name="Rectangle 56"/>
            <p:cNvSpPr/>
            <p:nvPr/>
          </p:nvSpPr>
          <p:spPr>
            <a:xfrm>
              <a:off x="1012007" y="1736498"/>
              <a:ext cx="287999" cy="179999"/>
            </a:xfrm>
            <a:prstGeom prst="rect">
              <a:avLst/>
            </a:prstGeom>
            <a:solidFill>
              <a:srgbClr val="00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1323046" y="1906826"/>
              <a:ext cx="106241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/>
                  <a:cs typeface="Arial"/>
                </a:rPr>
                <a:t>Apoplast</a:t>
              </a:r>
            </a:p>
          </p:txBody>
        </p:sp>
        <p:sp>
          <p:nvSpPr>
            <p:cNvPr id="59" name="Rectangle 58"/>
            <p:cNvSpPr/>
            <p:nvPr/>
          </p:nvSpPr>
          <p:spPr>
            <a:xfrm>
              <a:off x="1012007" y="1997517"/>
              <a:ext cx="287999" cy="179999"/>
            </a:xfrm>
            <a:prstGeom prst="rect">
              <a:avLst/>
            </a:prstGeom>
            <a:solidFill>
              <a:schemeClr val="accent5">
                <a:lumMod val="7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1323046" y="2155209"/>
              <a:ext cx="9730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/>
                  <a:cs typeface="Arial"/>
                </a:rPr>
                <a:t>Vacuole</a:t>
              </a:r>
            </a:p>
          </p:txBody>
        </p:sp>
        <p:sp>
          <p:nvSpPr>
            <p:cNvPr id="61" name="Rectangle 60"/>
            <p:cNvSpPr/>
            <p:nvPr/>
          </p:nvSpPr>
          <p:spPr>
            <a:xfrm>
              <a:off x="1012007" y="2245900"/>
              <a:ext cx="287999" cy="179999"/>
            </a:xfrm>
            <a:prstGeom prst="rect">
              <a:avLst/>
            </a:prstGeom>
            <a:solidFill>
              <a:schemeClr val="accent4">
                <a:lumMod val="7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1323046" y="2416228"/>
              <a:ext cx="134794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/>
                  <a:cs typeface="Arial"/>
                </a:rPr>
                <a:t>Peroxisome</a:t>
              </a:r>
            </a:p>
          </p:txBody>
        </p:sp>
        <p:sp>
          <p:nvSpPr>
            <p:cNvPr id="63" name="Rectangle 62"/>
            <p:cNvSpPr/>
            <p:nvPr/>
          </p:nvSpPr>
          <p:spPr>
            <a:xfrm>
              <a:off x="1012007" y="2506919"/>
              <a:ext cx="287999" cy="179999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1323046" y="2673885"/>
              <a:ext cx="105149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/>
                  <a:cs typeface="Arial"/>
                </a:rPr>
                <a:t>Secreted</a:t>
              </a:r>
            </a:p>
          </p:txBody>
        </p:sp>
        <p:sp>
          <p:nvSpPr>
            <p:cNvPr id="65" name="Rectangle 64"/>
            <p:cNvSpPr/>
            <p:nvPr/>
          </p:nvSpPr>
          <p:spPr>
            <a:xfrm>
              <a:off x="1012007" y="2764576"/>
              <a:ext cx="287999" cy="179999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1323046" y="2934904"/>
              <a:ext cx="117652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/>
                  <a:cs typeface="Arial"/>
                </a:rPr>
                <a:t>Ribosome</a:t>
              </a:r>
            </a:p>
          </p:txBody>
        </p:sp>
        <p:sp>
          <p:nvSpPr>
            <p:cNvPr id="67" name="Rectangle 66"/>
            <p:cNvSpPr/>
            <p:nvPr/>
          </p:nvSpPr>
          <p:spPr>
            <a:xfrm>
              <a:off x="1012007" y="3025595"/>
              <a:ext cx="287999" cy="179999"/>
            </a:xfrm>
            <a:prstGeom prst="rect">
              <a:avLst/>
            </a:prstGeom>
            <a:solidFill>
              <a:srgbClr val="FF8000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1323046" y="3192894"/>
              <a:ext cx="199806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/>
                  <a:cs typeface="Arial"/>
                </a:rPr>
                <a:t>Plasma membrane</a:t>
              </a:r>
            </a:p>
          </p:txBody>
        </p:sp>
        <p:sp>
          <p:nvSpPr>
            <p:cNvPr id="69" name="Rectangle 68"/>
            <p:cNvSpPr/>
            <p:nvPr/>
          </p:nvSpPr>
          <p:spPr>
            <a:xfrm>
              <a:off x="1012007" y="3283585"/>
              <a:ext cx="287999" cy="179999"/>
            </a:xfrm>
            <a:prstGeom prst="rect">
              <a:avLst/>
            </a:prstGeom>
            <a:solidFill>
              <a:srgbClr val="00FF00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1323046" y="3449283"/>
              <a:ext cx="110789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/>
                  <a:cs typeface="Arial"/>
                </a:rPr>
                <a:t>Unknown</a:t>
              </a:r>
            </a:p>
          </p:txBody>
        </p:sp>
        <p:sp>
          <p:nvSpPr>
            <p:cNvPr id="71" name="Rectangle 70"/>
            <p:cNvSpPr/>
            <p:nvPr/>
          </p:nvSpPr>
          <p:spPr>
            <a:xfrm>
              <a:off x="1012007" y="3539974"/>
              <a:ext cx="287999" cy="179999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B760F93E-819B-8A4D-8F53-263EEDDDF756}"/>
              </a:ext>
            </a:extLst>
          </p:cNvPr>
          <p:cNvSpPr txBox="1"/>
          <p:nvPr/>
        </p:nvSpPr>
        <p:spPr>
          <a:xfrm>
            <a:off x="-19878" y="6335385"/>
            <a:ext cx="62889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3.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Subcellular localization of the identified proteins</a:t>
            </a:r>
            <a:r>
              <a:rPr lang="el-G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9087612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</Words>
  <Application>Microsoft Macintosh PowerPoint</Application>
  <PresentationFormat>Προσαρμογή</PresentationFormat>
  <Paragraphs>19</Paragraphs>
  <Slides>1</Slides>
  <Notes>0</Notes>
  <HiddenSlides>0</HiddenSlides>
  <MMClips>0</MMClips>
  <ScaleCrop>false</ScaleCrop>
  <HeadingPairs>
    <vt:vector size="6" baseType="variant">
      <vt:variant>
        <vt:lpstr>Γραμματοσειρές που χρησιμοποιούνται</vt:lpstr>
      </vt:variant>
      <vt:variant>
        <vt:i4>2</vt:i4>
      </vt:variant>
      <vt:variant>
        <vt:lpstr>Θέμα</vt:lpstr>
      </vt:variant>
      <vt:variant>
        <vt:i4>1</vt:i4>
      </vt:variant>
      <vt:variant>
        <vt:lpstr>Τίτλοι διαφανειών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Παρουσίαση του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vangelos Karagiannis</dc:creator>
  <cp:lastModifiedBy>Athanasios Molasiotis</cp:lastModifiedBy>
  <cp:revision>4</cp:revision>
  <dcterms:created xsi:type="dcterms:W3CDTF">2018-07-09T10:47:03Z</dcterms:created>
  <dcterms:modified xsi:type="dcterms:W3CDTF">2019-10-01T12:52:16Z</dcterms:modified>
</cp:coreProperties>
</file>